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63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0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06152" y="5792795"/>
            <a:ext cx="9112469" cy="9976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7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parison of changes in BCL2, MCL1, BAX and BIM proteins induced by acute exposure of MOLM-14 cells to TUS versus the changes found in TUS-resistant lines 3 and 4. TUS/R cells were grown in drug-free medium for 48 h prior to being harvested for Western blot analysis. Data is mean ± SEM from 3 independent experiments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152" y="67560"/>
            <a:ext cx="8778240" cy="5882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04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1T03:1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